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4"/>
  </p:notesMasterIdLst>
  <p:sldIdLst>
    <p:sldId id="381" r:id="rId2"/>
    <p:sldId id="38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96FF"/>
    <a:srgbClr val="D5FC79"/>
    <a:srgbClr val="FF85FF"/>
    <a:srgbClr val="FFFD78"/>
    <a:srgbClr val="FF7E79"/>
    <a:srgbClr val="942093"/>
    <a:srgbClr val="00FA00"/>
    <a:srgbClr val="76D6FF"/>
    <a:srgbClr val="D9B5D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35" autoAdjust="0"/>
    <p:restoredTop sz="95342" autoAdjust="0"/>
  </p:normalViewPr>
  <p:slideViewPr>
    <p:cSldViewPr snapToGrid="0">
      <p:cViewPr varScale="1">
        <p:scale>
          <a:sx n="108" d="100"/>
          <a:sy n="108" d="100"/>
        </p:scale>
        <p:origin x="232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22755F-13BB-447B-B4FF-7B0E7298370B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A4BB9F-F4CF-4557-8D73-55DF94C478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217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A4BB9F-F4CF-4557-8D73-55DF94C4783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6692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92043-82F8-6805-C719-EC94B9FE31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3DC211-05D5-7FA9-9C65-AF65605F6E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8AB63C-CF38-B9C3-E15F-62EFC1812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E1407F-AE1D-CD34-1B5A-EA998F23A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C84C0F-ED2D-E69D-1824-9CA377E67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928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FC50F-4069-38E6-AF93-05C712E45D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C59902-E513-0061-1FD8-414F9839D4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EF641F-F068-FFC6-29E0-70A5242D3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3B982C-612B-0171-3F64-93B39DE27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84572-A2A4-F3ED-146D-902B0A4C0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801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ECB545-AB38-CFA8-AC91-0FAD16F668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B7A2C7-3C37-C492-1F0A-4A44F8FDF7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944170-981D-F4AC-99DD-61379BEF8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F42EDC-BAF7-8304-40BD-C3D17D501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8FA589-F821-257E-BA57-D17073ED8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154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8704A-6CC6-746D-16D7-3191C91F5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DB8F9A-6CB1-31E9-BF1B-F014A7A504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1BACE-A40F-A0F4-7150-1ED382979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5E3CAC-A1E5-91AB-22AB-BAFEBA1C1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10DB9-712B-55B9-A016-1F561CD63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200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89083-A406-189B-CA72-D32051E47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DD53E0-7750-9BBF-B601-C6996E0FD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6E1D5-BF51-1980-BAB0-E402010E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0984E2-05F6-BF07-87B9-6A168C83F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D0828A-90EF-2C2A-C6EF-1F0FF82AC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724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F36458-A5E7-8D95-E5DD-9752429CB2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011A4C-0279-4754-5844-54D34DAAD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CA3732-16D9-4C23-9690-ED884CF6C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E6C5F1-84C7-0B89-0099-160B2C3DE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EA59C8-6156-FC6B-0F53-C4079EF55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A3E2FB-A480-9C37-B98F-032ADC128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855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057C8-22EA-4207-A747-E39BFFEDF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6047E4-E7F8-7D1E-6AFF-EE3960269D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40B395-5412-236E-561A-EA34AD1DE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D849F2-5D17-7448-C372-50C86E1CAF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EE550F-C774-6758-A90E-C4EC2F5317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4AD723-FB92-7F3A-7E55-BD4BE2021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E224CA-A315-39B9-C02A-C2909F0E4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57A588-4D7B-A171-ADFB-683B35ACB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732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925E3-B041-52F2-78DA-E3ED77E07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A0578B-126F-62B7-9725-243155AFD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1A183D-0EA8-CF90-8AB2-7266262D3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E79AAE-88E3-81B0-606C-2252FC05E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16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7FE639-4018-73EC-9762-1AD7F26ED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EC5D69-DA87-4002-9303-49148E14D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6BDB8A-C24F-824F-A6C8-045683F2A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099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5EA2C-003D-E55E-C6EC-CC6003D61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DAE75-5280-EDF6-A246-F54950F811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ECEDC4-4639-0082-EBAD-9E799283B9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44C586-8948-212B-FB37-8C78E0324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B1D1F-375D-3F6D-BDF5-D3050CE33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C99B79-7C9D-0DED-063F-7216E1F1D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09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5B48D-F063-D560-F2E9-189699877E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79F3A5-AFEA-BAEA-9AB2-440830B13A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F7826-C0A9-8EE1-8FA2-923076047E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FDF213-DA77-F447-487B-EB6E6D95F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C33B3F-D2AC-AEF1-4A0A-5B9C61C01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24E886-5641-316B-FB2B-8E84E1151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588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76C8D1-72F8-5FBC-1AAC-957ABA1A0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5B336C-BC76-A469-1AE3-6EF76494CA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31CD0C-0D0A-6C69-5850-5CA66499E7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8B7C6-0E24-4908-85CB-F530C13E77C9}" type="datetimeFigureOut">
              <a:rPr lang="en-US" smtClean="0"/>
              <a:t>5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F82A1-5D5C-2523-FA4D-9ACC511B8F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D811D-EFC7-BF7D-DFB5-DEA4201E6F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60A45-0022-4DE9-98EC-4F8545E3A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697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1DF4D39F-E0BA-EE35-6D1E-164400ACB4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1" descr="A pipe with a pipe attached to it&#10;&#10;Description automatically generated">
            <a:extLst>
              <a:ext uri="{FF2B5EF4-FFF2-40B4-BE49-F238E27FC236}">
                <a16:creationId xmlns:a16="http://schemas.microsoft.com/office/drawing/2014/main" id="{A89D1FBB-9A3A-7470-64D7-D5E0B79C3A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9195" y="1001202"/>
            <a:ext cx="3317876" cy="4587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689085DF-15B9-A0E3-D9E4-148C2355BB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0478" y="359869"/>
            <a:ext cx="417531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pplemental Figure 1A Airlift Biofilter</a:t>
            </a:r>
            <a:endParaRPr kumimoji="0" lang="en-US" altLang="en-US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3281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5F6772D-7421-E344-FDD0-5C984087987B}"/>
              </a:ext>
            </a:extLst>
          </p:cNvPr>
          <p:cNvSpPr txBox="1"/>
          <p:nvPr/>
        </p:nvSpPr>
        <p:spPr>
          <a:xfrm>
            <a:off x="877344" y="605195"/>
            <a:ext cx="113053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l Figure S1B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rvival proportions of catfish in control (A) and florfenicol treatment groups (B)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587C0B7-C6B2-E089-939F-45306F95E3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204"/>
          <a:stretch/>
        </p:blipFill>
        <p:spPr>
          <a:xfrm>
            <a:off x="1043599" y="1950458"/>
            <a:ext cx="5486400" cy="319314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846B75B-FF4B-6068-63CE-659BCBF13CA9}"/>
              </a:ext>
            </a:extLst>
          </p:cNvPr>
          <p:cNvSpPr txBox="1"/>
          <p:nvPr/>
        </p:nvSpPr>
        <p:spPr>
          <a:xfrm>
            <a:off x="1133707" y="1794618"/>
            <a:ext cx="8903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60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6E7C5A0-682E-73F5-8701-61A66FAAE2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9999" y="1950458"/>
            <a:ext cx="4699000" cy="31877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C2B58C5B-4BC6-5311-E029-1528A6A09B88}"/>
              </a:ext>
            </a:extLst>
          </p:cNvPr>
          <p:cNvSpPr txBox="1"/>
          <p:nvPr/>
        </p:nvSpPr>
        <p:spPr>
          <a:xfrm>
            <a:off x="6620107" y="1804764"/>
            <a:ext cx="8903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60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2470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18</TotalTime>
  <Words>28</Words>
  <Application>Microsoft Macintosh PowerPoint</Application>
  <PresentationFormat>Widescreen</PresentationFormat>
  <Paragraphs>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Hongye</dc:creator>
  <cp:lastModifiedBy>Hongye Wang</cp:lastModifiedBy>
  <cp:revision>74</cp:revision>
  <dcterms:created xsi:type="dcterms:W3CDTF">2022-11-07T05:32:18Z</dcterms:created>
  <dcterms:modified xsi:type="dcterms:W3CDTF">2025-05-01T18:37:55Z</dcterms:modified>
</cp:coreProperties>
</file>